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32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1025" name="图片 2" descr="Figur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4461" y="18637"/>
            <a:ext cx="7155077" cy="5445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25760" y="5583057"/>
            <a:ext cx="8892480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</a:t>
            </a:r>
            <a:r>
              <a:rPr lang="en-US" altLang="zh-CN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.1</a:t>
            </a:r>
            <a:r>
              <a:rPr kumimoji="0" lang="zh-CN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：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serum AQP4-IgG titer (upper left), simple McGill pain questionnaire (SF-MPQ), MRI lesion segment of spinal cord (upper right) and Hauser walking index (lower right) decreased (p&lt;0.05) after MMF treatment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2355652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462595" y="6021288"/>
            <a:ext cx="781236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.Fig.2</a:t>
            </a:r>
            <a:r>
              <a:rPr kumimoji="0" lang="zh-CN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：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orest Plot Showing the Expanded Disability Status Scale Score of Patients With </a:t>
            </a:r>
            <a:r>
              <a:rPr kumimoji="0" lang="en-US" altLang="zh-CN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euromyelitis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ptica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Spectrum Disorders After MMF Therapy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1175199" y="32955"/>
            <a:ext cx="6387151" cy="5733256"/>
            <a:chOff x="1175199" y="32955"/>
            <a:chExt cx="6387151" cy="5733256"/>
          </a:xfrm>
        </p:grpSpPr>
        <p:pic>
          <p:nvPicPr>
            <p:cNvPr id="2049" name="图片 4" descr="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226"/>
            <a:stretch>
              <a:fillRect/>
            </a:stretch>
          </p:blipFill>
          <p:spPr bwMode="auto">
            <a:xfrm>
              <a:off x="1175199" y="32955"/>
              <a:ext cx="6387151" cy="57332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94953" y="562127"/>
              <a:ext cx="252984" cy="185928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4869" y="1057509"/>
              <a:ext cx="252984" cy="185928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5535" y="1547087"/>
              <a:ext cx="252984" cy="185928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4612" y="1988840"/>
              <a:ext cx="252984" cy="185928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2104" y="2420888"/>
              <a:ext cx="252984" cy="185928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2618" y="2899583"/>
              <a:ext cx="252984" cy="18592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244376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827584" y="6021288"/>
            <a:ext cx="7776864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.Fig.3: Forest Plot Showing the adverse effects of Patients With </a:t>
            </a:r>
            <a:r>
              <a:rPr kumimoji="0" lang="en-US" altLang="zh-CN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euromyelitis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ptica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Spectrum Disorders After MMF Therapy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738246" y="-3484"/>
            <a:ext cx="7667508" cy="5736740"/>
            <a:chOff x="738246" y="-3484"/>
            <a:chExt cx="7667508" cy="5736740"/>
          </a:xfrm>
        </p:grpSpPr>
        <p:pic>
          <p:nvPicPr>
            <p:cNvPr id="3073" name="图片 5" descr="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439"/>
            <a:stretch>
              <a:fillRect/>
            </a:stretch>
          </p:blipFill>
          <p:spPr bwMode="auto">
            <a:xfrm>
              <a:off x="738246" y="-3484"/>
              <a:ext cx="7667508" cy="57367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5656" y="575574"/>
              <a:ext cx="252984" cy="185928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1502" y="1052736"/>
              <a:ext cx="252984" cy="185928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9164" y="1471337"/>
              <a:ext cx="252984" cy="185928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5656" y="1876491"/>
              <a:ext cx="252984" cy="185928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 flipV="1">
              <a:off x="1920153" y="2321996"/>
              <a:ext cx="242688" cy="178361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 flipV="1">
              <a:off x="1413544" y="2686525"/>
              <a:ext cx="242688" cy="178361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 flipV="1">
              <a:off x="1416399" y="3087180"/>
              <a:ext cx="242688" cy="17836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97262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82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cynthia0218</dc:creator>
  <cp:lastModifiedBy>acynthia0218</cp:lastModifiedBy>
  <cp:revision>3</cp:revision>
  <dcterms:created xsi:type="dcterms:W3CDTF">2018-05-23T12:52:45Z</dcterms:created>
  <dcterms:modified xsi:type="dcterms:W3CDTF">2018-07-23T14:37:26Z</dcterms:modified>
</cp:coreProperties>
</file>